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735763" cy="98663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61" autoAdjust="0"/>
    <p:restoredTop sz="94660"/>
  </p:normalViewPr>
  <p:slideViewPr>
    <p:cSldViewPr>
      <p:cViewPr varScale="1">
        <p:scale>
          <a:sx n="69" d="100"/>
          <a:sy n="69" d="100"/>
        </p:scale>
        <p:origin x="-132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r">
              <a:defRPr sz="1200"/>
            </a:lvl1pPr>
          </a:lstStyle>
          <a:p>
            <a:fld id="{24B17DEB-0904-4369-A6EA-ACB00E3A52A9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3" rIns="91425" bIns="45713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25" tIns="45713" rIns="91425" bIns="45713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r">
              <a:defRPr sz="1200"/>
            </a:lvl1pPr>
          </a:lstStyle>
          <a:p>
            <a:fld id="{27C71963-4059-4562-914A-FF42F7120A56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901700" y="739775"/>
            <a:ext cx="4932363" cy="3700463"/>
          </a:xfrm>
        </p:spPr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C71963-4059-4562-914A-FF42F7120A56}" type="slidenum">
              <a:rPr lang="ru-RU" smtClean="0"/>
              <a:pPr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3851920" y="460674"/>
            <a:ext cx="4968552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3. Assembly and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toeprinting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of 48S and 80S translation initiation complexes in nuclease-treated rabbit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reticulocyte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(RRL) with alternative </a:t>
            </a:r>
            <a:r>
              <a:rPr lang="en-US" sz="1000" b="1" i="1" dirty="0" smtClean="0">
                <a:latin typeface="Arial" pitchFamily="34" charset="0"/>
                <a:cs typeface="Arial" pitchFamily="34" charset="0"/>
              </a:rPr>
              <a:t>YB-1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mRNA. 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he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oeprint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ssay was performed as described previously (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Dmitriev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t al., 2003.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FEBS letter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533, 99-104). To assemble the translation initiation complexes, a nuclease-treated RRL was employed. First, a 10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aster mix containing 7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RRL, 10 U of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ibonucleas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inhibitor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iboLock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Fermenta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, and 10 mM MgAc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was prepared. To assemble 48S and 80S initiation complexes, 0.4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50 m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guanylimidodiphosphat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(GMP-PNP) water solution , 0.4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50 mM MgAc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nd 1.2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water or 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water solution of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ycloheximid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(10 mg/ml) and 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water were added to this master mix. In control experiment, 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water solution of 20 mM cap analog  (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7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mGpppG that inhibits 40S binding to mRNA) and 0.4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50 mM MgAc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(2 mM) were added.  </a:t>
            </a:r>
          </a:p>
          <a:p>
            <a:pPr indent="457200"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The mixtures were incubated for 5 min at 30 °C, followed by addition of 0.5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mRNA (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 annealed with 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[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P]-labeled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oeprint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primer (5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, 8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RT-Mix (25 mM MgAc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1.25 m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dNTP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25 m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ris–HC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pH 7.5, 125 m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C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1.25 m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dithiothreit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, 4.4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water and 0.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evertAi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Premium reverse transcriptase (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Fermenta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200 U/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μ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 per each assay, and the samples were incubated for 15 min at 30°C. The mixtures were carefully phenol-purified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products were precipitated with ethanol overnight and finally analyzed using a 6% sequencing gel. The primer 5′-GGTGTACAAATACATCTTCCTTGGTGTC-3′ complementary to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exo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3 of the long alternative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 YB-1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mRNA sequence was used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products were compared with a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dideoxynucleotid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sequence ladder obtained by using the same primer and the appropriate plasmid DNA. </a:t>
            </a:r>
            <a:endParaRPr lang="ru-RU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" name="Группа 29"/>
          <p:cNvGrpSpPr/>
          <p:nvPr/>
        </p:nvGrpSpPr>
        <p:grpSpPr>
          <a:xfrm>
            <a:off x="376486" y="169600"/>
            <a:ext cx="3766887" cy="5691674"/>
            <a:chOff x="376486" y="-117977"/>
            <a:chExt cx="3766886" cy="5691674"/>
          </a:xfrm>
        </p:grpSpPr>
        <p:pic>
          <p:nvPicPr>
            <p:cNvPr id="2150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928662" y="942960"/>
              <a:ext cx="2124075" cy="463073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1946363" y="453173"/>
              <a:ext cx="782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GMP-PNP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2239399" y="451584"/>
              <a:ext cx="7809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baseline="30000" dirty="0" smtClean="0">
                  <a:latin typeface="Arial" pitchFamily="34" charset="0"/>
                  <a:cs typeface="Arial" pitchFamily="34" charset="0"/>
                </a:rPr>
                <a:t>7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mGpppG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382733" y="301689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ycloheximide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88308" y="697685"/>
              <a:ext cx="282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71604" y="700066"/>
              <a:ext cx="282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47749" y="702455"/>
              <a:ext cx="282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31043" y="704836"/>
              <a:ext cx="282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G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8" name="Группа 27"/>
            <p:cNvGrpSpPr/>
            <p:nvPr/>
          </p:nvGrpSpPr>
          <p:grpSpPr>
            <a:xfrm>
              <a:off x="3100382" y="2586729"/>
              <a:ext cx="108000" cy="216000"/>
              <a:chOff x="3929058" y="2072373"/>
              <a:chExt cx="142876" cy="216000"/>
            </a:xfrm>
          </p:grpSpPr>
          <p:cxnSp>
            <p:nvCxnSpPr>
              <p:cNvPr id="24" name="Прямая соединительная линия 23"/>
              <p:cNvCxnSpPr/>
              <p:nvPr/>
            </p:nvCxnSpPr>
            <p:spPr>
              <a:xfrm>
                <a:off x="3929058" y="2074059"/>
                <a:ext cx="1428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Прямая соединительная линия 24"/>
              <p:cNvCxnSpPr/>
              <p:nvPr/>
            </p:nvCxnSpPr>
            <p:spPr>
              <a:xfrm>
                <a:off x="3929058" y="2283611"/>
                <a:ext cx="1428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Прямая соединительная линия 25"/>
              <p:cNvCxnSpPr/>
              <p:nvPr/>
            </p:nvCxnSpPr>
            <p:spPr>
              <a:xfrm rot="16200000" flipV="1">
                <a:off x="3956022" y="2180373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" name="TextBox 32"/>
            <p:cNvSpPr txBox="1"/>
            <p:nvPr/>
          </p:nvSpPr>
          <p:spPr>
            <a:xfrm>
              <a:off x="3143240" y="2586034"/>
              <a:ext cx="10001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+16-+18</a:t>
              </a:r>
              <a:endParaRPr lang="ru-RU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1" name="Группа 20"/>
            <p:cNvGrpSpPr/>
            <p:nvPr/>
          </p:nvGrpSpPr>
          <p:grpSpPr>
            <a:xfrm flipH="1">
              <a:off x="772468" y="1717972"/>
              <a:ext cx="108000" cy="144000"/>
              <a:chOff x="3929058" y="2072373"/>
              <a:chExt cx="142876" cy="216000"/>
            </a:xfrm>
          </p:grpSpPr>
          <p:cxnSp>
            <p:nvCxnSpPr>
              <p:cNvPr id="22" name="Прямая соединительная линия 21"/>
              <p:cNvCxnSpPr/>
              <p:nvPr/>
            </p:nvCxnSpPr>
            <p:spPr>
              <a:xfrm>
                <a:off x="3929058" y="2074059"/>
                <a:ext cx="1428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Прямая соединительная линия 22"/>
              <p:cNvCxnSpPr/>
              <p:nvPr/>
            </p:nvCxnSpPr>
            <p:spPr>
              <a:xfrm>
                <a:off x="3929058" y="2283611"/>
                <a:ext cx="1428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Прямая соединительная линия 26"/>
              <p:cNvCxnSpPr/>
              <p:nvPr/>
            </p:nvCxnSpPr>
            <p:spPr>
              <a:xfrm rot="16200000" flipV="1">
                <a:off x="3956022" y="2180373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Прямоугольник 35"/>
            <p:cNvSpPr/>
            <p:nvPr/>
          </p:nvSpPr>
          <p:spPr>
            <a:xfrm>
              <a:off x="376486" y="1671340"/>
              <a:ext cx="47000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AUG</a:t>
              </a:r>
              <a:endParaRPr lang="ru-RU" dirty="0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3851920" y="4342716"/>
            <a:ext cx="4896544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 smtClean="0">
                <a:latin typeface="Arial" pitchFamily="34" charset="0"/>
                <a:cs typeface="Arial" pitchFamily="34" charset="0"/>
              </a:rPr>
              <a:t>This figure shows primer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extention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inhibition by the 48S and 80S complexes in RRL with alternative 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YB-1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mRNA. The 48S complex was assembled in the presence of a non-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hydrolyzabl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GTP analog GMP-PNP, the inhibitor of 60S ribosomal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subparticl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binding to the 48S complex. The </a:t>
            </a:r>
            <a:r>
              <a:rPr lang="ru-RU" sz="1100" dirty="0" smtClean="0">
                <a:latin typeface="Arial" pitchFamily="34" charset="0"/>
                <a:cs typeface="Arial" pitchFamily="34" charset="0"/>
              </a:rPr>
              <a:t>80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S complex was assembled in the presence of</a:t>
            </a:r>
            <a:r>
              <a:rPr lang="ru-RU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cycloheximid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, an inhibitor of translation elongation. The 48S (lane  1)  and 80S (lane  3)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toeprint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 are characterized by three bands at position +16 to +18 to the A of the initiation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codon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In control experiment with a cap analog (</a:t>
            </a:r>
            <a:r>
              <a:rPr lang="en-US" sz="1100" baseline="30000" dirty="0" smtClean="0">
                <a:latin typeface="Arial" pitchFamily="34" charset="0"/>
                <a:cs typeface="Arial" pitchFamily="34" charset="0"/>
              </a:rPr>
              <a:t>7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mGpppG) the +18 signal is absent, while signals of +16 and +17 are weak (lane 2). Together, these results suggest initiation of translation of alternative 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YB-1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mRNA from the AUG in question. </a:t>
            </a:r>
            <a:endParaRPr lang="ru-R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92174" y="5831077"/>
            <a:ext cx="2820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1</a:t>
            </a:r>
            <a:endParaRPr lang="ru-RU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494493" y="5831077"/>
            <a:ext cx="2820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</a:t>
            </a:r>
            <a:endParaRPr lang="ru-RU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796813" y="5831077"/>
            <a:ext cx="2820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</a:t>
            </a:r>
            <a:endParaRPr lang="ru-RU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2</TotalTime>
  <Words>509</Words>
  <Application>Microsoft Office PowerPoint</Application>
  <PresentationFormat>Экран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Lyabin</dc:creator>
  <cp:lastModifiedBy>Admin</cp:lastModifiedBy>
  <cp:revision>126</cp:revision>
  <dcterms:created xsi:type="dcterms:W3CDTF">2012-07-09T09:21:16Z</dcterms:created>
  <dcterms:modified xsi:type="dcterms:W3CDTF">2014-07-17T09:14:09Z</dcterms:modified>
</cp:coreProperties>
</file>